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9" r:id="rId3"/>
    <p:sldId id="260" r:id="rId4"/>
    <p:sldId id="263" r:id="rId5"/>
    <p:sldId id="264" r:id="rId6"/>
    <p:sldId id="265" r:id="rId7"/>
  </p:sldIdLst>
  <p:sldSz cx="9906000" cy="6858000" type="A4"/>
  <p:notesSz cx="7102475" cy="102330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93" autoAdjust="0"/>
    <p:restoredTop sz="94660"/>
  </p:normalViewPr>
  <p:slideViewPr>
    <p:cSldViewPr snapToGrid="0">
      <p:cViewPr>
        <p:scale>
          <a:sx n="100" d="100"/>
          <a:sy n="100" d="100"/>
        </p:scale>
        <p:origin x="456" y="-13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394D60-E9AD-4222-B9FE-CE7B60538B46}" type="datetimeFigureOut">
              <a:rPr lang="en-GB" smtClean="0"/>
              <a:t>13/06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06476A-41F6-49A0-95CE-1951D6267A49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870303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394D60-E9AD-4222-B9FE-CE7B60538B46}" type="datetimeFigureOut">
              <a:rPr lang="en-GB" smtClean="0"/>
              <a:t>13/06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06476A-41F6-49A0-95CE-1951D6267A49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97924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394D60-E9AD-4222-B9FE-CE7B60538B46}" type="datetimeFigureOut">
              <a:rPr lang="en-GB" smtClean="0"/>
              <a:t>13/06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06476A-41F6-49A0-95CE-1951D6267A49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8612521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394D60-E9AD-4222-B9FE-CE7B60538B46}" type="datetimeFigureOut">
              <a:rPr lang="en-GB" smtClean="0"/>
              <a:t>13/06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06476A-41F6-49A0-95CE-1951D6267A49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463855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394D60-E9AD-4222-B9FE-CE7B60538B46}" type="datetimeFigureOut">
              <a:rPr lang="en-GB" smtClean="0"/>
              <a:t>13/06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06476A-41F6-49A0-95CE-1951D6267A49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362427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394D60-E9AD-4222-B9FE-CE7B60538B46}" type="datetimeFigureOut">
              <a:rPr lang="en-GB" smtClean="0"/>
              <a:t>13/06/2018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06476A-41F6-49A0-95CE-1951D6267A49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1801667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394D60-E9AD-4222-B9FE-CE7B60538B46}" type="datetimeFigureOut">
              <a:rPr lang="en-GB" smtClean="0"/>
              <a:t>13/06/2018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06476A-41F6-49A0-95CE-1951D6267A49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9251641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394D60-E9AD-4222-B9FE-CE7B60538B46}" type="datetimeFigureOut">
              <a:rPr lang="en-GB" smtClean="0"/>
              <a:t>13/06/2018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06476A-41F6-49A0-95CE-1951D6267A49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8672167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394D60-E9AD-4222-B9FE-CE7B60538B46}" type="datetimeFigureOut">
              <a:rPr lang="en-GB" smtClean="0"/>
              <a:t>13/06/2018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06476A-41F6-49A0-95CE-1951D6267A49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5960824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394D60-E9AD-4222-B9FE-CE7B60538B46}" type="datetimeFigureOut">
              <a:rPr lang="en-GB" smtClean="0"/>
              <a:t>13/06/2018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06476A-41F6-49A0-95CE-1951D6267A49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1376143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394D60-E9AD-4222-B9FE-CE7B60538B46}" type="datetimeFigureOut">
              <a:rPr lang="en-GB" smtClean="0"/>
              <a:t>13/06/2018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06476A-41F6-49A0-95CE-1951D6267A49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4227074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394D60-E9AD-4222-B9FE-CE7B60538B46}" type="datetimeFigureOut">
              <a:rPr lang="en-GB" smtClean="0"/>
              <a:t>13/06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06476A-41F6-49A0-95CE-1951D6267A49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6501183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GB" dirty="0" smtClean="0"/>
              <a:t>Supplementary Web material</a:t>
            </a:r>
            <a:endParaRPr lang="en-GB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060676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0" y="704474"/>
            <a:ext cx="7726795" cy="3425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13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. Fig. 1 Association between close genetic relatedness (12 or fewer single nucleotide variations between samples), and shared epidemiology and MIRU-VNTR profiles</a:t>
            </a:r>
          </a:p>
          <a:p>
            <a:endParaRPr lang="en-GB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3130" y="1267570"/>
            <a:ext cx="8172450" cy="3815194"/>
          </a:xfrm>
          <a:prstGeom prst="rect">
            <a:avLst/>
          </a:prstGeom>
        </p:spPr>
      </p:pic>
      <p:sp>
        <p:nvSpPr>
          <p:cNvPr id="7" name="Rectangle 6"/>
          <p:cNvSpPr/>
          <p:nvPr/>
        </p:nvSpPr>
        <p:spPr>
          <a:xfrm>
            <a:off x="0" y="5473317"/>
            <a:ext cx="9303026" cy="3425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813" dirty="0"/>
              <a:t>Legend: The odds ratio favouring closely related isolates (defined by having twelve or fewer single nucleotide variants between them) when isolate pairs share a series of epidemiological properties or MIRU-VNTR profiles.  PPV denotes positive predictive values.  n refers to the number of subjects having the property described.  For example, there were 801 female subjects.</a:t>
            </a:r>
          </a:p>
        </p:txBody>
      </p:sp>
    </p:spTree>
    <p:extLst>
      <p:ext uri="{BB962C8B-B14F-4D97-AF65-F5344CB8AC3E}">
        <p14:creationId xmlns:p14="http://schemas.microsoft.com/office/powerpoint/2010/main" val="25159012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0" y="704474"/>
            <a:ext cx="7726795" cy="3425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13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. Fig. 2 Association between close genetic relatedness (20 or fewer single nucleotide variations between samples), and shared epidemiology and MIRU-VNTR profiles</a:t>
            </a:r>
          </a:p>
          <a:p>
            <a:endParaRPr lang="en-GB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0" y="5473317"/>
            <a:ext cx="9303026" cy="3425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813" dirty="0"/>
              <a:t>Legend: The odds ratio favouring closely related isolates (defined by having 20 or fewer single nucleotide variants between them) when isolate pairs share a series of epidemiological properties or MIRU-VNTR profiles.  PPV denotes positive predictive values.  n refers to the number of subjects having the property described.  For example, there were 801 female subjects.</a:t>
            </a: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287787"/>
            <a:ext cx="8172450" cy="38151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525667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0" y="704474"/>
            <a:ext cx="7348487" cy="3425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13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. Fig. 3 Association between close genetic relatedness (12 or fewer single nucleotide variations between samples), bacterial lineage and MIRU-VNTR profiles</a:t>
            </a:r>
          </a:p>
          <a:p>
            <a:endParaRPr lang="en-GB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1" y="5389836"/>
            <a:ext cx="9516220" cy="4676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Bef>
                <a:spcPts val="488"/>
              </a:spcBef>
              <a:spcAft>
                <a:spcPts val="488"/>
              </a:spcAft>
            </a:pPr>
            <a:r>
              <a:rPr lang="en-GB" sz="813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egend</a:t>
            </a:r>
            <a:r>
              <a:rPr lang="en-GB" sz="813" dirty="0"/>
              <a:t> The odds ratio favouring closely related isolates (defined by having twelve or fewer single nucleotide variants between them) when isolate pairs share </a:t>
            </a:r>
            <a:r>
              <a:rPr lang="en-GB" sz="813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 particular lineage (relative to lineage 4), or having identical or similar MIRU-VNTR profiles.  PPV denotes positive predictive values.  n refers to the number of subjects having the property described.  For example, there were 954 subjects of lineage 4.</a:t>
            </a: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6500" y="1380935"/>
            <a:ext cx="8172450" cy="38151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293529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Content Placeholder 9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337974"/>
            <a:ext cx="7573242" cy="3535462"/>
          </a:xfrm>
        </p:spPr>
      </p:pic>
      <p:sp>
        <p:nvSpPr>
          <p:cNvPr id="6" name="TextBox 5"/>
          <p:cNvSpPr txBox="1"/>
          <p:nvPr/>
        </p:nvSpPr>
        <p:spPr>
          <a:xfrm>
            <a:off x="0" y="704474"/>
            <a:ext cx="7348487" cy="2174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13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. Fig. 4 Association between close genetic relatedness (20 or fewer single nucleotide variations between samples), bacterial lineage and MIRU-VNTR profiles</a:t>
            </a:r>
          </a:p>
        </p:txBody>
      </p:sp>
      <p:sp>
        <p:nvSpPr>
          <p:cNvPr id="7" name="Rectangle 6"/>
          <p:cNvSpPr/>
          <p:nvPr/>
        </p:nvSpPr>
        <p:spPr>
          <a:xfrm>
            <a:off x="90446" y="5389836"/>
            <a:ext cx="9425774" cy="4676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Bef>
                <a:spcPts val="488"/>
              </a:spcBef>
              <a:spcAft>
                <a:spcPts val="488"/>
              </a:spcAft>
            </a:pPr>
            <a:r>
              <a:rPr lang="en-GB" sz="813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egend:</a:t>
            </a:r>
            <a:r>
              <a:rPr lang="en-GB" sz="813" dirty="0"/>
              <a:t> The odds ratio favouring closely related isolates (defined by having twenty or fewer single nucleotide variants between them) when isolate pairs share </a:t>
            </a:r>
            <a:r>
              <a:rPr lang="en-GB" sz="813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 particular lineage (relative to lineage 4), or having identical or similar MIRU-VNTR profiles.  PPV denotes positive predictive values.  n refers to the number of subjects having the property described.  For example, there were 954 subjects of lineage 4.</a:t>
            </a:r>
          </a:p>
        </p:txBody>
      </p:sp>
    </p:spTree>
    <p:extLst>
      <p:ext uri="{BB962C8B-B14F-4D97-AF65-F5344CB8AC3E}">
        <p14:creationId xmlns:p14="http://schemas.microsoft.com/office/powerpoint/2010/main" val="232941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0" y="704474"/>
            <a:ext cx="6167073" cy="2174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13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. Fig. </a:t>
            </a:r>
            <a:r>
              <a:rPr lang="en-GB" sz="813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 </a:t>
            </a:r>
            <a:r>
              <a:rPr lang="en-GB" sz="813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sociation between close genetic relatedness </a:t>
            </a:r>
            <a:r>
              <a:rPr lang="en-GB" sz="813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geographical distance between the residence of subjects with TB isolation</a:t>
            </a:r>
            <a:endParaRPr lang="en-GB" sz="813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90446" y="5389836"/>
            <a:ext cx="9425774" cy="4676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Bef>
                <a:spcPts val="488"/>
              </a:spcBef>
              <a:spcAft>
                <a:spcPts val="488"/>
              </a:spcAft>
            </a:pPr>
            <a:r>
              <a:rPr lang="en-GB" sz="813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egend:</a:t>
            </a:r>
            <a:r>
              <a:rPr lang="en-GB" sz="813" dirty="0"/>
              <a:t> The odds ratio favouring </a:t>
            </a:r>
            <a:r>
              <a:rPr lang="en-GB" sz="813" dirty="0" smtClean="0"/>
              <a:t>subjects being resident within a geographical distance, when they are vs. are not closely </a:t>
            </a:r>
            <a:r>
              <a:rPr lang="en-GB" sz="813" dirty="0" smtClean="0"/>
              <a:t>genetically r</a:t>
            </a:r>
            <a:r>
              <a:rPr lang="en-GB" sz="813" dirty="0" smtClean="0"/>
              <a:t>elated isolates.  Four different definitions of ‘closely genetically related’ are use: 0 SNV different, 1-3 SNV different, 4 or 5 SNV different, or 6-12 </a:t>
            </a:r>
            <a:r>
              <a:rPr lang="en-GB" sz="813" smtClean="0"/>
              <a:t>SNV different.</a:t>
            </a:r>
            <a:endParaRPr lang="en-GB" sz="813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360" y="1094929"/>
            <a:ext cx="9022080" cy="42290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957891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0</TotalTime>
  <Words>450</Words>
  <Application>Microsoft Office PowerPoint</Application>
  <PresentationFormat>A4 Paper (210x297 mm)</PresentationFormat>
  <Paragraphs>11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 Theme</vt:lpstr>
      <vt:lpstr>Supplementary Web material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Oxfor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s</dc:title>
  <dc:creator>David Wyllie</dc:creator>
  <cp:lastModifiedBy>David Wyllie</cp:lastModifiedBy>
  <cp:revision>21</cp:revision>
  <cp:lastPrinted>2018-01-26T23:55:14Z</cp:lastPrinted>
  <dcterms:created xsi:type="dcterms:W3CDTF">2018-01-04T23:32:51Z</dcterms:created>
  <dcterms:modified xsi:type="dcterms:W3CDTF">2018-06-13T16:02:17Z</dcterms:modified>
</cp:coreProperties>
</file>